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61" r:id="rId4"/>
    <p:sldId id="262" r:id="rId5"/>
    <p:sldId id="26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BAF"/>
    <a:srgbClr val="E69082"/>
    <a:srgbClr val="E6AFEF"/>
    <a:srgbClr val="B700EF"/>
    <a:srgbClr val="B9EDFF"/>
    <a:srgbClr val="E200F3"/>
    <a:srgbClr val="00EB03"/>
    <a:srgbClr val="00FF00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379" autoAdjust="0"/>
    <p:restoredTop sz="94660"/>
  </p:normalViewPr>
  <p:slideViewPr>
    <p:cSldViewPr snapToGrid="0">
      <p:cViewPr varScale="1">
        <p:scale>
          <a:sx n="84" d="100"/>
          <a:sy n="84" d="100"/>
        </p:scale>
        <p:origin x="566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283D5-F04E-4F11-B8D0-B4B9191F1533}" type="datetimeFigureOut">
              <a:rPr lang="en-GB" smtClean="0"/>
              <a:t>24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930F-26DB-4633-9D37-F5B222C3E6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1024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283D5-F04E-4F11-B8D0-B4B9191F1533}" type="datetimeFigureOut">
              <a:rPr lang="en-GB" smtClean="0"/>
              <a:t>24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930F-26DB-4633-9D37-F5B222C3E6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2867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283D5-F04E-4F11-B8D0-B4B9191F1533}" type="datetimeFigureOut">
              <a:rPr lang="en-GB" smtClean="0"/>
              <a:t>24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930F-26DB-4633-9D37-F5B222C3E6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9817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283D5-F04E-4F11-B8D0-B4B9191F1533}" type="datetimeFigureOut">
              <a:rPr lang="en-GB" smtClean="0"/>
              <a:t>24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930F-26DB-4633-9D37-F5B222C3E6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702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283D5-F04E-4F11-B8D0-B4B9191F1533}" type="datetimeFigureOut">
              <a:rPr lang="en-GB" smtClean="0"/>
              <a:t>24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930F-26DB-4633-9D37-F5B222C3E6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326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283D5-F04E-4F11-B8D0-B4B9191F1533}" type="datetimeFigureOut">
              <a:rPr lang="en-GB" smtClean="0"/>
              <a:t>24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930F-26DB-4633-9D37-F5B222C3E6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2227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283D5-F04E-4F11-B8D0-B4B9191F1533}" type="datetimeFigureOut">
              <a:rPr lang="en-GB" smtClean="0"/>
              <a:t>24/10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930F-26DB-4633-9D37-F5B222C3E6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7860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283D5-F04E-4F11-B8D0-B4B9191F1533}" type="datetimeFigureOut">
              <a:rPr lang="en-GB" smtClean="0"/>
              <a:t>24/10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930F-26DB-4633-9D37-F5B222C3E6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6580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283D5-F04E-4F11-B8D0-B4B9191F1533}" type="datetimeFigureOut">
              <a:rPr lang="en-GB" smtClean="0"/>
              <a:t>24/10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930F-26DB-4633-9D37-F5B222C3E6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5357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283D5-F04E-4F11-B8D0-B4B9191F1533}" type="datetimeFigureOut">
              <a:rPr lang="en-GB" smtClean="0"/>
              <a:t>24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930F-26DB-4633-9D37-F5B222C3E6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0907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283D5-F04E-4F11-B8D0-B4B9191F1533}" type="datetimeFigureOut">
              <a:rPr lang="en-GB" smtClean="0"/>
              <a:t>24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930F-26DB-4633-9D37-F5B222C3E6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802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0283D5-F04E-4F11-B8D0-B4B9191F1533}" type="datetimeFigureOut">
              <a:rPr lang="en-GB" smtClean="0"/>
              <a:t>24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7B930F-26DB-4633-9D37-F5B222C3E6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455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753689" y="6476198"/>
            <a:ext cx="47480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Odds of intending to take up screening (OR ± 95% CI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-19586" y="-31876"/>
            <a:ext cx="1221158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</a:t>
            </a:r>
            <a:r>
              <a:rPr lang="en-GB" b="1" dirty="0" smtClean="0"/>
              <a:t>1a. </a:t>
            </a:r>
            <a:r>
              <a:rPr lang="en-GB" sz="1600" dirty="0"/>
              <a:t>The association between participant characteristics and intention to attend </a:t>
            </a:r>
            <a:r>
              <a:rPr lang="en-GB" sz="1600" dirty="0" smtClean="0"/>
              <a:t>urine test based screening. </a:t>
            </a:r>
            <a:r>
              <a:rPr lang="en-GB" sz="1600" dirty="0"/>
              <a:t>Odds ratios (OR) are adjusted for all factors in the figure.  Cancer worry is measured on a scale from 3-15, perceived risk of cancer from 0-100, beliefs about cancer outcomes from 1.3-6.6, beliefs about cancer treatment from 1-5, burden/inconvenience and worry about the tests from 1-5.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045030" y="936532"/>
            <a:ext cx="3858986" cy="52247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</a:pPr>
            <a:r>
              <a:rPr lang="en-GB" sz="1600" dirty="0"/>
              <a:t>Sex (male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Age (5 years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University level education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Non-white ethnicity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Fair/poor general health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USA (ref UK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Other country (ref UK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Lower income group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MI (5kg/m</a:t>
            </a:r>
            <a:r>
              <a:rPr lang="en-GB" sz="1600" baseline="30000" dirty="0"/>
              <a:t>2</a:t>
            </a:r>
            <a:r>
              <a:rPr lang="en-GB" sz="1600" dirty="0"/>
              <a:t>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Ex-smoker (ref non-smoker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Current smoker (ref non-smoker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History of any cancer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Family history of kidney cancer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Cancer </a:t>
            </a:r>
            <a:r>
              <a:rPr lang="en-GB" sz="1600" dirty="0" smtClean="0"/>
              <a:t>worry</a:t>
            </a:r>
            <a:endParaRPr lang="en-GB" sz="1600" dirty="0"/>
          </a:p>
          <a:p>
            <a:pPr>
              <a:lnSpc>
                <a:spcPct val="107000"/>
              </a:lnSpc>
            </a:pPr>
            <a:r>
              <a:rPr lang="en-GB" sz="1600" dirty="0"/>
              <a:t>Perceived risk of </a:t>
            </a:r>
            <a:r>
              <a:rPr lang="en-GB" sz="1600" dirty="0" smtClean="0"/>
              <a:t>cancer</a:t>
            </a:r>
            <a:endParaRPr lang="en-GB" sz="1600" dirty="0"/>
          </a:p>
          <a:p>
            <a:pPr>
              <a:lnSpc>
                <a:spcPct val="107000"/>
              </a:lnSpc>
            </a:pPr>
            <a:r>
              <a:rPr lang="en-GB" sz="1600" dirty="0"/>
              <a:t>Beliefs about cancer </a:t>
            </a:r>
            <a:r>
              <a:rPr lang="en-GB" sz="1600" dirty="0" smtClean="0"/>
              <a:t>outcomes</a:t>
            </a:r>
            <a:endParaRPr lang="en-GB" sz="1600" dirty="0"/>
          </a:p>
          <a:p>
            <a:pPr>
              <a:lnSpc>
                <a:spcPct val="107000"/>
              </a:lnSpc>
            </a:pPr>
            <a:r>
              <a:rPr lang="en-GB" sz="1600" dirty="0"/>
              <a:t>Beliefs about cancer </a:t>
            </a:r>
            <a:r>
              <a:rPr lang="en-GB" sz="1600" dirty="0" smtClean="0"/>
              <a:t>treatment</a:t>
            </a:r>
            <a:endParaRPr lang="en-GB" sz="1600" dirty="0"/>
          </a:p>
          <a:p>
            <a:pPr>
              <a:lnSpc>
                <a:spcPct val="107000"/>
              </a:lnSpc>
            </a:pPr>
            <a:r>
              <a:rPr lang="en-GB" sz="1600" dirty="0"/>
              <a:t>Burden/inconvenience of </a:t>
            </a:r>
            <a:r>
              <a:rPr lang="en-GB" sz="1600" dirty="0" smtClean="0"/>
              <a:t>tests</a:t>
            </a:r>
            <a:endParaRPr lang="en-GB" sz="1600" dirty="0"/>
          </a:p>
          <a:p>
            <a:pPr>
              <a:lnSpc>
                <a:spcPct val="107000"/>
              </a:lnSpc>
            </a:pPr>
            <a:r>
              <a:rPr lang="en-GB" sz="1600" dirty="0"/>
              <a:t>Worry about the </a:t>
            </a:r>
            <a:r>
              <a:rPr lang="en-GB" sz="1600" dirty="0" smtClean="0"/>
              <a:t>tests</a:t>
            </a:r>
            <a:endParaRPr lang="en-GB" sz="1600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2"/>
          <a:srcRect l="37730" t="4810" r="3589" b="3790"/>
          <a:stretch/>
        </p:blipFill>
        <p:spPr>
          <a:xfrm>
            <a:off x="4131722" y="956389"/>
            <a:ext cx="4826012" cy="550165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257800" y="6106866"/>
            <a:ext cx="29718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dirty="0" smtClean="0"/>
              <a:t>0.5        1           2              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470070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839910" y="6384501"/>
            <a:ext cx="47807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Odds of intending to take up screening (OR ± 95% CI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-19586" y="-31876"/>
            <a:ext cx="12025657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</a:t>
            </a:r>
            <a:r>
              <a:rPr lang="en-GB" b="1" dirty="0" smtClean="0"/>
              <a:t>1b. </a:t>
            </a:r>
            <a:r>
              <a:rPr lang="en-GB" sz="1600" dirty="0"/>
              <a:t>The association between participant characteristics and intention to attend </a:t>
            </a:r>
            <a:r>
              <a:rPr lang="en-GB" sz="1600" dirty="0" smtClean="0"/>
              <a:t>blood test </a:t>
            </a:r>
            <a:r>
              <a:rPr lang="en-GB" sz="1600" dirty="0"/>
              <a:t>based screening. Odds ratios (OR) are adjusted for all factors in the figure. Cancer worry is measured on a scale from 3-15, perceived risk of cancer from 0-100, beliefs about cancer outcomes from 1.3-6.6, beliefs about cancer treatment from 1-5, burden/inconvenience and worry about the tests from 1-5.</a:t>
            </a:r>
            <a:endParaRPr lang="en-GB" sz="16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1045030" y="981381"/>
            <a:ext cx="3858986" cy="52247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</a:pPr>
            <a:r>
              <a:rPr lang="en-GB" sz="1600" dirty="0"/>
              <a:t>Sex (male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Age (5 years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University level education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Non-white ethnicity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Fair/poor general health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USA (ref UK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Other country (ref UK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Lower income group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MI (5kg/m</a:t>
            </a:r>
            <a:r>
              <a:rPr lang="en-GB" sz="1600" baseline="30000" dirty="0"/>
              <a:t>2</a:t>
            </a:r>
            <a:r>
              <a:rPr lang="en-GB" sz="1600" dirty="0"/>
              <a:t>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Ex-smoker (ref non-smoker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Current smoker (ref non-smoker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History of any cancer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Family history of kidney cancer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Cancer worry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Perceived risk of cancer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eliefs about cancer outcomes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eliefs about cancer treatment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urden/inconvenience of tests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Worry about the tests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38273" t="4847" r="3732" b="4555"/>
          <a:stretch/>
        </p:blipFill>
        <p:spPr>
          <a:xfrm>
            <a:off x="4424993" y="995047"/>
            <a:ext cx="4713606" cy="538945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305040" y="6110657"/>
            <a:ext cx="29718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dirty="0" smtClean="0"/>
              <a:t>0.5         1          2               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00326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959782" y="6455107"/>
            <a:ext cx="46936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Odds of intending to take up screening (OR ± 95% CI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-19586" y="-31876"/>
            <a:ext cx="11961649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</a:t>
            </a:r>
            <a:r>
              <a:rPr lang="en-GB" b="1" dirty="0" smtClean="0"/>
              <a:t>1c. </a:t>
            </a:r>
            <a:r>
              <a:rPr lang="en-GB" sz="1600" dirty="0"/>
              <a:t>The association between participant characteristics and intention to attend </a:t>
            </a:r>
            <a:r>
              <a:rPr lang="en-GB" sz="1600" dirty="0" smtClean="0"/>
              <a:t>ultrasound </a:t>
            </a:r>
            <a:r>
              <a:rPr lang="en-GB" sz="1600" dirty="0"/>
              <a:t>based screening. Odds ratios (OR) are adjusted for all factors in the figure. Cancer worry is measured on a scale from 3-15, perceived risk of cancer from 0-100, beliefs about cancer outcomes from 1.3-6.6, beliefs about cancer treatment from 1-5, burden/inconvenience and worry about the tests from 1-5.</a:t>
            </a:r>
            <a:endParaRPr lang="en-GB" sz="16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1045030" y="840301"/>
            <a:ext cx="3858986" cy="4834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</a:pPr>
            <a:r>
              <a:rPr lang="en-GB" sz="1600" dirty="0"/>
              <a:t>Sex (male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Age (5 years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University level education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Non-white ethnicity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Fair/poor general health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USA (ref UK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Other country (ref UK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Lower income group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MI (5kg/m</a:t>
            </a:r>
            <a:r>
              <a:rPr lang="en-GB" sz="1600" baseline="30000" dirty="0"/>
              <a:t>2</a:t>
            </a:r>
            <a:r>
              <a:rPr lang="en-GB" sz="1600" dirty="0"/>
              <a:t>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Ex-smoker (ref non-smoker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Current smoker (ref non-smoker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History of any cancer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Cancer worry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Perceived risk of cancer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eliefs about cancer outcomes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eliefs about cancer treatment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urden/inconvenience of tests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Worry about the tests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37730" t="4889" r="4269"/>
          <a:stretch/>
        </p:blipFill>
        <p:spPr>
          <a:xfrm>
            <a:off x="5003800" y="950637"/>
            <a:ext cx="4343400" cy="521304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468112" y="5666781"/>
            <a:ext cx="29718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dirty="0" smtClean="0"/>
              <a:t>0.5        1         2             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132233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744686" y="6461499"/>
            <a:ext cx="48242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Odds of intending to take up screening (OR ± 95% CI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-19586" y="-31876"/>
            <a:ext cx="1221158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</a:t>
            </a:r>
            <a:r>
              <a:rPr lang="en-GB" b="1" dirty="0" smtClean="0"/>
              <a:t>1d. </a:t>
            </a:r>
            <a:r>
              <a:rPr lang="en-GB" sz="1600" dirty="0"/>
              <a:t>The association between participant characteristics and intention to attend </a:t>
            </a:r>
            <a:r>
              <a:rPr lang="en-GB" sz="1600" dirty="0" smtClean="0"/>
              <a:t>low-dose CT </a:t>
            </a:r>
            <a:r>
              <a:rPr lang="en-GB" sz="1600" dirty="0"/>
              <a:t>based screening. Odds ratios (OR) are adjusted for all factors in the figure. Cancer worry is measured on a scale from 3-15, perceived risk of cancer from 0-100, beliefs about cancer outcomes from 1.3-6.6, beliefs about cancer treatment from 1-5, burden/inconvenience and worry about the tests from 1-5.</a:t>
            </a:r>
            <a:endParaRPr lang="en-GB" sz="16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1045030" y="892119"/>
            <a:ext cx="3858986" cy="52247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</a:pPr>
            <a:r>
              <a:rPr lang="en-GB" sz="1600" dirty="0"/>
              <a:t>Sex (male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Age (5 years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University level education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Non-white ethnicity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Fair/poor general health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USA (ref UK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Other country (ref UK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Lower income group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MI (5kg/m</a:t>
            </a:r>
            <a:r>
              <a:rPr lang="en-GB" sz="1600" baseline="30000" dirty="0"/>
              <a:t>2</a:t>
            </a:r>
            <a:r>
              <a:rPr lang="en-GB" sz="1600" dirty="0"/>
              <a:t>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Ex-smoker (ref non-smoker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Current smoker (ref non-smoker)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History of any cancer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Family history of kidney cancer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Cancer worry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Perceived risk of cancer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eliefs about cancer outcomes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eliefs about cancer treatment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Burden/inconvenience of tests</a:t>
            </a:r>
          </a:p>
          <a:p>
            <a:pPr>
              <a:lnSpc>
                <a:spcPct val="107000"/>
              </a:lnSpc>
            </a:pPr>
            <a:r>
              <a:rPr lang="en-GB" sz="1600" dirty="0"/>
              <a:t>Worry about the tests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37528" t="5037" r="4085" b="3422"/>
          <a:stretch/>
        </p:blipFill>
        <p:spPr>
          <a:xfrm>
            <a:off x="4631266" y="960120"/>
            <a:ext cx="4648200" cy="5334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074920" y="5932217"/>
            <a:ext cx="29718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dirty="0" smtClean="0"/>
              <a:t>0.5       1        2           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917966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810001" y="6509253"/>
            <a:ext cx="50201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Odds of intending to take up screening (OR ± 95% CI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-19586" y="-31876"/>
            <a:ext cx="1221158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</a:t>
            </a:r>
            <a:r>
              <a:rPr lang="en-GB" b="1" dirty="0" smtClean="0"/>
              <a:t>1e. </a:t>
            </a:r>
            <a:r>
              <a:rPr lang="en-GB" sz="1600" dirty="0"/>
              <a:t>The association between participant characteristics and intention to attend </a:t>
            </a:r>
            <a:r>
              <a:rPr lang="en-GB" sz="1600" dirty="0" smtClean="0"/>
              <a:t>low-dose CT </a:t>
            </a:r>
            <a:r>
              <a:rPr lang="en-GB" sz="1600" dirty="0"/>
              <a:t>based </a:t>
            </a:r>
            <a:r>
              <a:rPr lang="en-GB" sz="1600" dirty="0" smtClean="0"/>
              <a:t>screening combined with lung cancer screening. </a:t>
            </a:r>
            <a:r>
              <a:rPr lang="en-GB" sz="1600" dirty="0"/>
              <a:t>Odds ratios (OR) are adjusted for all factors in the figure. Cancer worry is measured on a scale from 3-15, perceived risk of cancer from 0-100, beliefs about cancer outcomes from 1.3-6.6, beliefs about cancer treatment from 1-5, burden/inconvenience and worry about the tests from 1-5.</a:t>
            </a:r>
            <a:endParaRPr lang="en-GB" sz="16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1045030" y="1007754"/>
            <a:ext cx="3858986" cy="5095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GB" sz="1600" dirty="0"/>
              <a:t>Sex (male)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Age (5 years)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University level education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Fair/poor general health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USA (ref UK)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Other country (ref UK)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Lower income group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BMI (5kg/m</a:t>
            </a:r>
            <a:r>
              <a:rPr lang="en-GB" sz="1600" baseline="30000" dirty="0"/>
              <a:t>2</a:t>
            </a:r>
            <a:r>
              <a:rPr lang="en-GB" sz="1600" dirty="0"/>
              <a:t>)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Ex-smoker (ref non-smoker)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Current smoker (ref non-smoker)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History of any cancer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Cancer worry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Perceived risk of cancer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Beliefs about cancer outcomes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Beliefs about cancer treatment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Burden/inconvenience of tests</a:t>
            </a:r>
          </a:p>
          <a:p>
            <a:pPr>
              <a:lnSpc>
                <a:spcPct val="120000"/>
              </a:lnSpc>
            </a:pPr>
            <a:r>
              <a:rPr lang="en-GB" sz="1600" dirty="0"/>
              <a:t>Worry about the tests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37749" t="4960" r="3803" b="4549"/>
          <a:stretch/>
        </p:blipFill>
        <p:spPr>
          <a:xfrm>
            <a:off x="4205968" y="1033018"/>
            <a:ext cx="4766733" cy="540173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358384" y="6094107"/>
            <a:ext cx="29718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dirty="0" smtClean="0"/>
              <a:t>0.5           1            2                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2540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6</TotalTime>
  <Words>823</Words>
  <Application>Microsoft Office PowerPoint</Application>
  <PresentationFormat>Widescreen</PresentationFormat>
  <Paragraphs>10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ragh Harvey-Kelly</dc:creator>
  <cp:lastModifiedBy>Juliet Usher-Smith</cp:lastModifiedBy>
  <cp:revision>34</cp:revision>
  <dcterms:created xsi:type="dcterms:W3CDTF">2020-03-23T10:09:31Z</dcterms:created>
  <dcterms:modified xsi:type="dcterms:W3CDTF">2020-10-24T11:39:16Z</dcterms:modified>
</cp:coreProperties>
</file>